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06" autoAdjust="0"/>
    <p:restoredTop sz="94660"/>
  </p:normalViewPr>
  <p:slideViewPr>
    <p:cSldViewPr>
      <p:cViewPr varScale="1">
        <p:scale>
          <a:sx n="104" d="100"/>
          <a:sy n="104" d="100"/>
        </p:scale>
        <p:origin x="1578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32036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51722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JP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86086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rouwers et al (2020) Diabetologia DOI 10.1007/s00125-019-05024-3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338437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nfounding and mediation. The relationship between NAFLD and CVD, as reported in observational studies, can be explained by confounding or mediation</a:t>
            </a:r>
          </a:p>
        </p:txBody>
      </p:sp>
      <p:pic>
        <p:nvPicPr>
          <p:cNvPr id="11" name="Picture 10" descr="A picture containing clock, meter&#10;&#10;Description automatically generated">
            <a:extLst>
              <a:ext uri="{FF2B5EF4-FFF2-40B4-BE49-F238E27FC236}">
                <a16:creationId xmlns:a16="http://schemas.microsoft.com/office/drawing/2014/main" id="{423CBE07-381A-4B41-89F8-B3B3E44FFB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926" y="0"/>
            <a:ext cx="4908522" cy="5930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6318" y="5733256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rouwers et al (2020) Diabetologia DOI 10.1007/s00125-019-05024-3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Biologically plausible mechanisms that link NAFLD to the pathogenesis of an atherosclerotic lesion</a:t>
            </a:r>
          </a:p>
        </p:txBody>
      </p:sp>
      <p:pic>
        <p:nvPicPr>
          <p:cNvPr id="5" name="Picture 4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93479DF0-27A1-4CD5-B8FE-1E284252C6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65127"/>
            <a:ext cx="9144000" cy="4927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5074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25705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rouwers et al (2020) Diabetologia DOI 10.1007/s00125-019-05024-3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4945" y="116632"/>
            <a:ext cx="88077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lationship of </a:t>
            </a:r>
            <a:r>
              <a:rPr lang="en-GB" sz="2000" b="1" i="1" dirty="0"/>
              <a:t>GCKR</a:t>
            </a:r>
            <a:r>
              <a:rPr lang="en-GB" sz="2000" b="1" dirty="0"/>
              <a:t>, </a:t>
            </a:r>
            <a:r>
              <a:rPr lang="en-GB" sz="2000" b="1" i="1" dirty="0"/>
              <a:t>PNPLA3</a:t>
            </a:r>
            <a:r>
              <a:rPr lang="en-GB" sz="2000" b="1" dirty="0"/>
              <a:t> and </a:t>
            </a:r>
            <a:r>
              <a:rPr lang="en-GB" sz="2000" b="1" i="1" dirty="0"/>
              <a:t>TM6SF2</a:t>
            </a:r>
            <a:r>
              <a:rPr lang="en-GB" sz="2000" b="1" dirty="0"/>
              <a:t> with plasma lipids, type 2 diabetes and CA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F88BB61-A300-4D99-A3BB-2568EAE2CB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6836" y="1124744"/>
            <a:ext cx="8676456" cy="4523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8061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</TotalTime>
  <Words>176</Words>
  <Application>Microsoft Office PowerPoint</Application>
  <PresentationFormat>On-screen Show (4:3)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6</cp:revision>
  <dcterms:created xsi:type="dcterms:W3CDTF">2016-06-15T12:53:43Z</dcterms:created>
  <dcterms:modified xsi:type="dcterms:W3CDTF">2019-11-07T16:13:32Z</dcterms:modified>
</cp:coreProperties>
</file>